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2" y="-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by Rassette" userId="b996ae3d-554d-4d8c-9dec-aea409c4f3f8" providerId="ADAL" clId="{C7BB534E-F5EB-485A-B442-ED74382471A7}"/>
    <pc:docChg chg="modSld">
      <pc:chgData name="Abby Rassette" userId="b996ae3d-554d-4d8c-9dec-aea409c4f3f8" providerId="ADAL" clId="{C7BB534E-F5EB-485A-B442-ED74382471A7}" dt="2023-09-11T14:41:52.902" v="0" actId="13926"/>
      <pc:docMkLst>
        <pc:docMk/>
      </pc:docMkLst>
      <pc:sldChg chg="modSp mod">
        <pc:chgData name="Abby Rassette" userId="b996ae3d-554d-4d8c-9dec-aea409c4f3f8" providerId="ADAL" clId="{C7BB534E-F5EB-485A-B442-ED74382471A7}" dt="2023-09-11T14:41:52.902" v="0" actId="13926"/>
        <pc:sldMkLst>
          <pc:docMk/>
          <pc:sldMk cId="2820131202" sldId="263"/>
        </pc:sldMkLst>
        <pc:spChg chg="mod">
          <ac:chgData name="Abby Rassette" userId="b996ae3d-554d-4d8c-9dec-aea409c4f3f8" providerId="ADAL" clId="{C7BB534E-F5EB-485A-B442-ED74382471A7}" dt="2023-09-11T14:41:52.902" v="0" actId="13926"/>
          <ac:spMkLst>
            <pc:docMk/>
            <pc:sldMk cId="2820131202" sldId="263"/>
            <ac:spMk id="7" creationId="{8AC7B903-D574-9C42-A65F-E42C0616BB9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A6C4D4-36F7-A707-C0AD-B68F697779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496026-655C-4B97-CC8D-1C0ECA42F0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4ED1F3-97D0-8B7D-2679-2300555AA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591657-07FE-BC17-1705-F357866ED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C75BC-F033-2612-61F2-680A23CDD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816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A5424-24D4-3AF4-53B9-FC5231D093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E3CA61-A65B-E7F4-B4D4-20BDDBFD2F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9AA2A6-7304-6AED-3A14-AF458BAF6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904962-D6E7-E62D-D69B-E7297E5D4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BEEBE8-7D4E-7DDB-FA15-94945717A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1629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50CC97-3A0C-E4DF-5B49-CF8683AB9F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D28FC1-DB50-9013-6A5C-CD12790BC5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922F0D-A995-36BA-0AFB-7A0ECED43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29C148-4485-BE8D-EA90-5ABD80FA1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29C10B-A0AE-955A-44D2-CBB56265B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966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66BAD-9194-43AF-53EF-DE42983E3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969284-CE20-4255-1F7A-BC6AC10687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F118CB-C019-2DF6-D3AB-7666C3920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2574A9-F703-F734-55D2-9EA6177361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0BC19C-7E17-8680-8D1E-C1717A6F2D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13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B257D8-AECB-BEF7-ADF3-B16093DB5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FDFF1F-6E07-C992-CB35-BC5AA85429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64914A-6EAA-12BA-26D0-0B8816648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EDF2AB-71D1-D6AF-947E-012E690B2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A681D-EF71-1C14-A9B4-F280F1384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601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64357-F729-AB53-F3B6-1EF20E23F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A16FEC-33C6-63C0-F6D4-B15D1974CF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27F3BE-3F67-145A-9B7C-EE2CB9E0A4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D38A4-24A4-E7C8-C8F7-2529A9B2E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60EEB3-689D-3E60-8418-3FE0D2573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4AE4F3-0014-BEF3-19F3-624E16D0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318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F65F6-BA6F-552D-5ACC-EC4E38BA0E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E775B5-3305-17B6-41A3-AB7293B4B8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7F9EF7-A2C8-6F0B-2057-4B7564F88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3E86AD-BC71-0DC6-B84F-E8E5AF2446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4EE4FC-1F1F-F417-4BA1-59D570033F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19D0BF-247E-7116-C6F0-FC48865CF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B85332-EA6A-33CA-6A01-4F86796B9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3E5639-FB87-B706-FE74-14DDD6E91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578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AE704F-0B54-240B-56A3-DD5CB3645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0F5E66-0943-AEF0-55EC-D2651926E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878254-5F94-1020-5B2F-FC1D7C8F3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1F6589-0FE0-BA65-0F9A-8E19F65AE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6617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4EB5DD-1AB3-9902-689C-5608268E7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FFA03F-478C-F76B-FD9F-CEBB730AF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C6D6C0-AAFC-55F8-0B58-B57BDF16F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786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65AF47-C863-0BF1-D6E8-46BAAFD6F5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9A88D2-94E7-7FD2-CBE9-58EBBF4D78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4C6923-0845-1828-D30B-5790E4D485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FE7901-7DB7-5B59-3CA8-55A2B0A98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CF3F39-CA1A-B575-313A-24AB677FB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9156D6-B13C-C2F5-D24B-C75709D32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2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54090-C7D7-491D-FD92-6D4E5C860F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F51E6F-3347-ED1D-218D-F1EDF05922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1CB5E5-0458-D31C-E13E-44D50B89A8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97CA93-A83F-B5F6-F2DD-6C73DCA34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7A7968-DE1C-2A28-9B29-CBE83210B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86FCAE-0929-D42E-8B8D-D4897D08D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2699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03B95C-2C4B-4461-BCBB-05FD9F543B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9301BA-1131-8BF0-EADD-AE013AA3E8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F3464D-BC84-D54D-9FC1-8378FA1B0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9C03C-1EF4-4D18-9312-17DCC20CEE89}" type="datetimeFigureOut">
              <a:rPr lang="en-GB" smtClean="0"/>
              <a:t>1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91030-3B2C-8502-827C-0C2A5D3D8F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BEB727-2F74-E3C9-0074-5846F54998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8050E-E26E-49E3-BEB9-DA61CB901F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5240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FE156D88-8085-4D67-02F4-66B42B70CE1D}"/>
              </a:ext>
            </a:extLst>
          </p:cNvPr>
          <p:cNvGrpSpPr/>
          <p:nvPr/>
        </p:nvGrpSpPr>
        <p:grpSpPr>
          <a:xfrm>
            <a:off x="702906" y="825765"/>
            <a:ext cx="7382505" cy="3642572"/>
            <a:chOff x="702906" y="839887"/>
            <a:chExt cx="7382505" cy="364257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9C68233-CB3B-113B-B0E3-F8BCEFFF14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2795" y="1005199"/>
              <a:ext cx="7312616" cy="347726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7958855-055B-4EEF-0288-8E76CC85F1CF}"/>
                </a:ext>
              </a:extLst>
            </p:cNvPr>
            <p:cNvSpPr txBox="1"/>
            <p:nvPr/>
          </p:nvSpPr>
          <p:spPr>
            <a:xfrm>
              <a:off x="702906" y="863224"/>
              <a:ext cx="562975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2400" b="1" dirty="0"/>
                <a:t>(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D19C83F-C30B-1335-F0FF-8EC731B07726}"/>
                </a:ext>
              </a:extLst>
            </p:cNvPr>
            <p:cNvSpPr txBox="1"/>
            <p:nvPr/>
          </p:nvSpPr>
          <p:spPr>
            <a:xfrm>
              <a:off x="4251107" y="963044"/>
              <a:ext cx="50206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/>
                <a:t>      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5E5BFDB-6A3D-ABEC-DFD5-FAD1737A1B06}"/>
                </a:ext>
              </a:extLst>
            </p:cNvPr>
            <p:cNvSpPr txBox="1"/>
            <p:nvPr/>
          </p:nvSpPr>
          <p:spPr>
            <a:xfrm>
              <a:off x="4207912" y="839887"/>
              <a:ext cx="83715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b="1" dirty="0"/>
                <a:t>(B)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E5C3626-2B24-ACCE-B996-E0CF959C913A}"/>
              </a:ext>
            </a:extLst>
          </p:cNvPr>
          <p:cNvSpPr txBox="1"/>
          <p:nvPr/>
        </p:nvSpPr>
        <p:spPr>
          <a:xfrm>
            <a:off x="0" y="0"/>
            <a:ext cx="36711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isawi et al. Petunia satellite repeats</a:t>
            </a:r>
          </a:p>
          <a:p>
            <a:r>
              <a:rPr lang="en-US" b="1" dirty="0"/>
              <a:t>Supplementary data Figure S2 </a:t>
            </a:r>
            <a:endParaRPr lang="en-GB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C7B903-D574-9C42-A65F-E42C0616BB9A}"/>
              </a:ext>
            </a:extLst>
          </p:cNvPr>
          <p:cNvSpPr txBox="1"/>
          <p:nvPr/>
        </p:nvSpPr>
        <p:spPr>
          <a:xfrm>
            <a:off x="702906" y="4734761"/>
            <a:ext cx="11014025" cy="21245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6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andem repeat organisation of PSAT1 sequences in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GB" sz="1600" i="1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lata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GB" sz="1600" i="1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xillaris</a:t>
            </a:r>
            <a:endParaRPr lang="en-GB" sz="1600" i="1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lf-dot plots of parts of scaffold:  (A)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nfS6101Scf00909 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total size about 1,820,000 bp)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the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. inflata S6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sembly (</a:t>
            </a:r>
            <a:r>
              <a:rPr lang="en-GB" sz="16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mbarely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t al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, 2016) showing tandem organisation between 360,000 </a:t>
            </a:r>
            <a:r>
              <a:rPr lang="en-GB" sz="16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t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415,000 </a:t>
            </a:r>
            <a:r>
              <a:rPr lang="en-GB" sz="16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t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dark blue squares and rectangles); red double arrows indicate further arrays with homology; a </a:t>
            </a:r>
            <a:r>
              <a:rPr lang="en-GB" sz="1600" kern="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troelement is inserted into the array between the second and third blocks of the repeat, with 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TRs (Long Terminal Repeats, seen as short diagonals in the corners). (B)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xiN162Scf01294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. </a:t>
            </a:r>
            <a:r>
              <a:rPr lang="en-GB" sz="1600" i="1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xillaris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sembly (</a:t>
            </a:r>
            <a:r>
              <a:rPr lang="en-GB" sz="16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mbarely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6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t al</a:t>
            </a:r>
            <a:r>
              <a:rPr lang="en-GB" sz="1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, 2016) showing about 2 kb array at the end of this scaffold (red arrows).</a:t>
            </a:r>
          </a:p>
          <a:p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8201312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5097E705-E5FA-7299-7D7C-231AA3B1DEC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" t="1444"/>
          <a:stretch/>
        </p:blipFill>
        <p:spPr>
          <a:xfrm>
            <a:off x="2074986" y="301451"/>
            <a:ext cx="9747616" cy="599239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861865D-A431-3202-5D9F-89E27825FE22}"/>
              </a:ext>
            </a:extLst>
          </p:cNvPr>
          <p:cNvSpPr txBox="1"/>
          <p:nvPr/>
        </p:nvSpPr>
        <p:spPr>
          <a:xfrm>
            <a:off x="369398" y="6017940"/>
            <a:ext cx="1133693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gure S2 </a:t>
            </a:r>
            <a:r>
              <a:rPr lang="en-GB" sz="1600" b="1" dirty="0" err="1"/>
              <a:t>cont</a:t>
            </a:r>
            <a:endParaRPr lang="en-GB" sz="1600" b="1" dirty="0"/>
          </a:p>
          <a:p>
            <a:r>
              <a:rPr lang="en-GB" sz="1600" dirty="0"/>
              <a:t>(C) Self dot blot of chromosome 5</a:t>
            </a:r>
            <a:r>
              <a:rPr lang="en-GB" sz="1600" i="1" dirty="0"/>
              <a:t> Peax403 </a:t>
            </a:r>
            <a:r>
              <a:rPr lang="en-GB" sz="1600" dirty="0"/>
              <a:t>assembly (CM040423.1 nt179,900,000 – 179,990,000) showing the PSAT1 and PSAT2 variant arrays (arrows) as seen in scaffold </a:t>
            </a:r>
            <a:r>
              <a:rPr lang="en-GB" sz="1600" i="1" dirty="0"/>
              <a:t>Peaxi162Scf00160</a:t>
            </a:r>
            <a:r>
              <a:rPr lang="en-GB" sz="1600" dirty="0"/>
              <a:t> (Fig. 2) near the end of the 181,081,908 bp long chromosome </a:t>
            </a:r>
          </a:p>
          <a:p>
            <a:endParaRPr lang="en-GB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646D543-F136-A55A-3D0B-C7C1449E33CD}"/>
              </a:ext>
            </a:extLst>
          </p:cNvPr>
          <p:cNvSpPr txBox="1"/>
          <p:nvPr/>
        </p:nvSpPr>
        <p:spPr>
          <a:xfrm>
            <a:off x="70719" y="63687"/>
            <a:ext cx="170783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isawi et al. Petunia satellite repeats</a:t>
            </a:r>
          </a:p>
          <a:p>
            <a:r>
              <a:rPr lang="en-US" b="1" dirty="0"/>
              <a:t>Supplementary data Figure S2 </a:t>
            </a:r>
            <a:r>
              <a:rPr lang="en-US" b="1" dirty="0" err="1"/>
              <a:t>cont</a:t>
            </a:r>
            <a:r>
              <a:rPr lang="en-US" b="1" dirty="0"/>
              <a:t> </a:t>
            </a:r>
            <a:endParaRPr lang="en-GB" b="1" dirty="0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4E03753-EFA0-159E-D21F-C43E621C2083}"/>
              </a:ext>
            </a:extLst>
          </p:cNvPr>
          <p:cNvCxnSpPr>
            <a:cxnSpLocks/>
          </p:cNvCxnSpPr>
          <p:nvPr/>
        </p:nvCxnSpPr>
        <p:spPr>
          <a:xfrm flipH="1">
            <a:off x="8111794" y="3680039"/>
            <a:ext cx="199148" cy="328174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31EE5C71-D7A6-6208-D381-B4327C6A7CDC}"/>
              </a:ext>
            </a:extLst>
          </p:cNvPr>
          <p:cNvCxnSpPr/>
          <p:nvPr/>
        </p:nvCxnSpPr>
        <p:spPr>
          <a:xfrm>
            <a:off x="7825693" y="4563585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3B5C524-1BE7-1788-A7B5-3A521A4F76A5}"/>
              </a:ext>
            </a:extLst>
          </p:cNvPr>
          <p:cNvGrpSpPr/>
          <p:nvPr/>
        </p:nvGrpSpPr>
        <p:grpSpPr>
          <a:xfrm>
            <a:off x="2677533" y="5800327"/>
            <a:ext cx="413896" cy="276999"/>
            <a:chOff x="11117865" y="5772500"/>
            <a:chExt cx="413896" cy="276999"/>
          </a:xfrm>
        </p:grpSpPr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828DC7CA-0236-9522-5D0C-848B989348BB}"/>
                </a:ext>
              </a:extLst>
            </p:cNvPr>
            <p:cNvCxnSpPr/>
            <p:nvPr/>
          </p:nvCxnSpPr>
          <p:spPr>
            <a:xfrm>
              <a:off x="11157921" y="6005315"/>
              <a:ext cx="3337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57A255B-72F3-A328-F88C-94D0ABD955C6}"/>
                </a:ext>
              </a:extLst>
            </p:cNvPr>
            <p:cNvSpPr txBox="1"/>
            <p:nvPr/>
          </p:nvSpPr>
          <p:spPr>
            <a:xfrm>
              <a:off x="11117865" y="5772500"/>
              <a:ext cx="4138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kb</a:t>
              </a:r>
              <a:endParaRPr lang="en-GB" sz="1200" dirty="0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75CAFFE-AAFD-043D-E7C8-5645663401A7}"/>
              </a:ext>
            </a:extLst>
          </p:cNvPr>
          <p:cNvSpPr txBox="1"/>
          <p:nvPr/>
        </p:nvSpPr>
        <p:spPr>
          <a:xfrm>
            <a:off x="8420431" y="3637722"/>
            <a:ext cx="1007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xiSAT1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CD2681E-451C-6364-F8E1-C7ADA29E5994}"/>
              </a:ext>
            </a:extLst>
          </p:cNvPr>
          <p:cNvSpPr txBox="1"/>
          <p:nvPr/>
        </p:nvSpPr>
        <p:spPr>
          <a:xfrm>
            <a:off x="5791845" y="1952449"/>
            <a:ext cx="1712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PaxiSAT2 </a:t>
            </a:r>
            <a:r>
              <a:rPr lang="en-US" dirty="0"/>
              <a:t>variant</a:t>
            </a:r>
            <a:endParaRPr lang="en-GB" dirty="0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2D38A02-0F57-C79C-4064-F5979E112D9F}"/>
              </a:ext>
            </a:extLst>
          </p:cNvPr>
          <p:cNvCxnSpPr>
            <a:cxnSpLocks/>
          </p:cNvCxnSpPr>
          <p:nvPr/>
        </p:nvCxnSpPr>
        <p:spPr>
          <a:xfrm flipH="1">
            <a:off x="6504199" y="2321781"/>
            <a:ext cx="234531" cy="247264"/>
          </a:xfrm>
          <a:prstGeom prst="straightConnector1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E8EB951-23AC-0B3C-5DF5-AA538511D83C}"/>
              </a:ext>
            </a:extLst>
          </p:cNvPr>
          <p:cNvSpPr txBox="1"/>
          <p:nvPr/>
        </p:nvSpPr>
        <p:spPr>
          <a:xfrm>
            <a:off x="1775013" y="95625"/>
            <a:ext cx="5998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(C)</a:t>
            </a:r>
            <a:endParaRPr lang="en-GB" sz="2800" b="1" dirty="0"/>
          </a:p>
        </p:txBody>
      </p:sp>
    </p:spTree>
    <p:extLst>
      <p:ext uri="{BB962C8B-B14F-4D97-AF65-F5344CB8AC3E}">
        <p14:creationId xmlns:p14="http://schemas.microsoft.com/office/powerpoint/2010/main" val="430015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2</TotalTime>
  <Words>225</Words>
  <Application>Microsoft Office PowerPoint</Application>
  <PresentationFormat>Widescreen</PresentationFormat>
  <Paragraphs>1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warzacher, Trude (Dr.)</dc:creator>
  <cp:lastModifiedBy>Abby Rassette</cp:lastModifiedBy>
  <cp:revision>27</cp:revision>
  <dcterms:created xsi:type="dcterms:W3CDTF">2023-04-04T07:54:28Z</dcterms:created>
  <dcterms:modified xsi:type="dcterms:W3CDTF">2023-09-11T14:41:55Z</dcterms:modified>
</cp:coreProperties>
</file>